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-342" y="-28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A2904E2-3D08-4B69-BA49-B4238C76CBD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4B99A9F4-18C6-43D8-AAF6-225C431BA5C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0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DA47B0B-1792-4D30-94C6-EB24157225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83828-C3C2-49A0-9FF9-C11A4B8B13B8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AF40430-CCD7-4D4C-82C2-7B1BE275B4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ADCCF03-74B5-49B4-926F-A4844DD9AD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BB0FD8-6AF8-4509-A7A1-9083AAFC41AA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7484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4FE0A5F-7977-4F46-8A45-BE6748E2E9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E2CAB63E-977C-4D03-B539-C5FBD0DD91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2A7F4546-FA97-4BB2-9DFA-1C8F60FC82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83828-C3C2-49A0-9FF9-C11A4B8B13B8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38734BA3-04EB-477A-B2A7-C8DE510E45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F49A59C-DB51-4475-8772-2FD8B7906E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BB0FD8-6AF8-4509-A7A1-9083AAFC41AA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86099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C41B2802-5B76-42EF-8170-2D55DCBA9D9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F9CA1A66-5645-4740-AFB0-62E765554D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A8BC789-B732-4745-BF25-0757C49F0B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83828-C3C2-49A0-9FF9-C11A4B8B13B8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1C98C5F-71DB-464F-9BB5-58D04A8ED5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42F488C-61C0-4211-886C-2CDCC5834A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BB0FD8-6AF8-4509-A7A1-9083AAFC41AA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15643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869A364-5DAF-4DED-8BDB-41D5F35291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92833AD9-954C-4C29-84E8-E4C7496F29E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446BD84F-24F2-4672-9635-7D10BB70C1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83828-C3C2-49A0-9FF9-C11A4B8B13B8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EBE90F6-5378-4866-B31D-35B4E0364E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813B306-23B2-4D42-926E-AB917807E3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BB0FD8-6AF8-4509-A7A1-9083AAFC41AA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38692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5368EF4-CCE0-4A43-B3AD-FF1940153B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EAD48FDA-9136-4B87-AF44-60DE17750B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B470BCE-BA4B-4E05-B880-AEEE9A3D0E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83828-C3C2-49A0-9FF9-C11A4B8B13B8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6EE2FCE-9B18-4BF1-9F7F-8BE4456F6D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D0A2AE95-1929-4EBA-A4CE-C963EBF519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BB0FD8-6AF8-4509-A7A1-9083AAFC41AA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9108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AC463B0-94B6-4E73-AC76-8C91177AE9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9D435411-7F41-48B9-9F88-7C7F83ED82E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A9E67181-E71D-446B-9E30-84606DB797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69DCBD8C-66A8-44D1-8509-C14B58DC64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83828-C3C2-49A0-9FF9-C11A4B8B13B8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D5930D3F-A6FF-4D68-A11B-C2AA789B1E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06070F9B-C3B8-45A9-BB6B-FE47E95A61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BB0FD8-6AF8-4509-A7A1-9083AAFC41AA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98746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BB43CEF-EAE3-48D5-982E-8DFD9B2077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E26AD706-DDCA-4B7F-B5C2-FA36B0588D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DAB19316-BDA6-44BD-843A-9FEBBC053C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06A6D7DD-46BC-4FC2-BCC4-56645E79C9E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F9814E19-C4B9-4A1A-9B36-0398DDA16CF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E7A66F7D-C425-4109-924E-59D280663B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83828-C3C2-49A0-9FF9-C11A4B8B13B8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45FF6E0C-0A8E-405C-92C5-1E98AACB5E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19D28436-8AE7-449D-87B0-0CAA94130D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BB0FD8-6AF8-4509-A7A1-9083AAFC41AA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44519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D90D0C0-E53C-46AE-BACA-B38E8BB408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0973A524-445D-444D-92E7-DC0DF1DCFE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83828-C3C2-49A0-9FF9-C11A4B8B13B8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6C320CA1-FDA0-44FC-98C3-F8119551A0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47E0710D-BDE5-46B9-9A10-A1BA869093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BB0FD8-6AF8-4509-A7A1-9083AAFC41AA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01350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7B9DDE9B-CEE2-483D-8EF1-E359948BA4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83828-C3C2-49A0-9FF9-C11A4B8B13B8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CFBD4336-8285-4E98-9F62-E8C74275C7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507252C0-63E5-4C35-B88A-6D5E768964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BB0FD8-6AF8-4509-A7A1-9083AAFC41AA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62703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89AF50D-D43B-4010-944E-84BF02CE50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1FD52AD5-3ED1-4B14-82C0-CC89555448B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EB37074F-8E6F-4E37-A4C3-1D69EB94C9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7E73EE0A-1D5C-4832-A6F9-68A6064B9F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83828-C3C2-49A0-9FF9-C11A4B8B13B8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C092BC68-74F4-4FB3-9C29-83C8A3715A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92CF5F67-3FEA-4D00-A1B6-B8C4178773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BB0FD8-6AF8-4509-A7A1-9083AAFC41AA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08754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01D9763-EC7D-406D-9A65-B529475713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6A4406A4-9B6A-41AB-B372-7447A3BBFB5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13832D6A-4B9B-44E2-B70A-6CE9CA788F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84958515-7FA7-43A8-B13E-77BC58D5DB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83828-C3C2-49A0-9FF9-C11A4B8B13B8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070163D1-5BE1-4561-8999-360ABEF3E2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A8BC38A8-9619-4336-962F-4C64D1AD55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BB0FD8-6AF8-4509-A7A1-9083AAFC41AA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24782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F1DFE459-78D7-48F4-95C4-7FC54A7F3F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9483962E-8BF1-4CD2-B59B-88C81D5F05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FCE5807-251F-4583-A093-60B16F7D4B1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883828-C3C2-49A0-9FF9-C11A4B8B13B8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DE06369B-BF30-4848-A4D1-245E0756462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D8A01EA7-E3D4-4BC0-9E68-1D6E414CB32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BB0FD8-6AF8-4509-A7A1-9083AAFC41AA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82266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3" indent="-228603" algn="l" defTabSz="914411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4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0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6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7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3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1 Grupo"/>
          <p:cNvGrpSpPr/>
          <p:nvPr/>
        </p:nvGrpSpPr>
        <p:grpSpPr>
          <a:xfrm>
            <a:off x="425186" y="827148"/>
            <a:ext cx="10845244" cy="5621743"/>
            <a:chOff x="425186" y="827148"/>
            <a:chExt cx="10845244" cy="5621743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xmlns="" id="{ACED88F5-2070-40FC-B466-892E972CAC1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667" r="2342"/>
            <a:stretch/>
          </p:blipFill>
          <p:spPr>
            <a:xfrm>
              <a:off x="5544423" y="827148"/>
              <a:ext cx="4631422" cy="4616017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xmlns="" id="{3D6174BA-B045-4157-B0F4-0BF7FE6463F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667" r="2342"/>
            <a:stretch/>
          </p:blipFill>
          <p:spPr>
            <a:xfrm>
              <a:off x="744927" y="827148"/>
              <a:ext cx="4631421" cy="4616018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xmlns="" id="{FC51178A-F99E-4168-B6C3-4461BF0047F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2001"/>
            <a:stretch/>
          </p:blipFill>
          <p:spPr>
            <a:xfrm>
              <a:off x="10365822" y="2539538"/>
              <a:ext cx="904608" cy="1191237"/>
            </a:xfrm>
            <a:prstGeom prst="rect">
              <a:avLst/>
            </a:prstGeom>
          </p:spPr>
        </p:pic>
        <p:sp>
          <p:nvSpPr>
            <p:cNvPr id="12" name="CuadroTexto 6">
              <a:extLst>
                <a:ext uri="{FF2B5EF4-FFF2-40B4-BE49-F238E27FC236}">
                  <a16:creationId xmlns:a16="http://schemas.microsoft.com/office/drawing/2014/main" xmlns="" id="{7CC33A0D-8E68-4BAC-B158-D0E1641CCBF6}"/>
                </a:ext>
              </a:extLst>
            </p:cNvPr>
            <p:cNvSpPr txBox="1"/>
            <p:nvPr/>
          </p:nvSpPr>
          <p:spPr>
            <a:xfrm>
              <a:off x="425186" y="5802560"/>
              <a:ext cx="10445985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 err="1"/>
                <a:t>Fernández-Melero</a:t>
              </a:r>
              <a:r>
                <a:rPr lang="en-US" b="1" dirty="0"/>
                <a:t> et </a:t>
              </a:r>
              <a:r>
                <a:rPr lang="en-US" b="1"/>
                <a:t>al</a:t>
              </a:r>
              <a:r>
                <a:rPr lang="en-US" b="1" smtClean="0"/>
                <a:t>. Figure </a:t>
              </a:r>
              <a:r>
                <a:rPr lang="en-US" b="1" dirty="0"/>
                <a:t>S2. </a:t>
              </a:r>
              <a:r>
                <a:rPr lang="en-US" dirty="0"/>
                <a:t>Dot plots of HannDeb2-Chr04 aligned with (A) HanHA89-Chr04 and (B) HdebPI468691-s0002 showing the </a:t>
              </a:r>
              <a:r>
                <a:rPr lang="en-US" dirty="0" err="1"/>
                <a:t>introgressed</a:t>
              </a:r>
              <a:r>
                <a:rPr lang="en-US" dirty="0"/>
                <a:t> </a:t>
              </a:r>
              <a:r>
                <a:rPr lang="en-US" dirty="0" smtClean="0"/>
                <a:t>17-Mbp </a:t>
              </a:r>
              <a:r>
                <a:rPr lang="en-US" dirty="0"/>
                <a:t>regio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189471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</TotalTime>
  <Words>27</Words>
  <Application>Microsoft Office PowerPoint</Application>
  <PresentationFormat>Personalizado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Office Them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len Fernandez Melero</dc:creator>
  <cp:lastModifiedBy>Bego</cp:lastModifiedBy>
  <cp:revision>7</cp:revision>
  <dcterms:created xsi:type="dcterms:W3CDTF">2025-08-20T12:28:37Z</dcterms:created>
  <dcterms:modified xsi:type="dcterms:W3CDTF">2026-02-11T11:59:12Z</dcterms:modified>
</cp:coreProperties>
</file>